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321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433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993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54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720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138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236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98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972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210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33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888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D3BEC0-AC08-4181-9083-34B5137DCF34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50F8A2-FBCF-4AA5-AC76-DA5F53CC2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927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026F4B2-466F-8A93-C07A-2708917BF2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1186" y="366842"/>
            <a:ext cx="4335623" cy="23774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C8AB229-FEE6-842C-07E3-A7CF236DB2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1186" y="2834271"/>
            <a:ext cx="4335623" cy="237744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F4C8927-4D1B-765E-48AE-CAAC5CF7567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6704"/>
          <a:stretch/>
        </p:blipFill>
        <p:spPr>
          <a:xfrm>
            <a:off x="1261186" y="5301699"/>
            <a:ext cx="4335623" cy="237744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4D99576-8CDE-7857-0066-F6E6B10FCEF5}"/>
              </a:ext>
            </a:extLst>
          </p:cNvPr>
          <p:cNvSpPr txBox="1"/>
          <p:nvPr/>
        </p:nvSpPr>
        <p:spPr>
          <a:xfrm>
            <a:off x="638626" y="362848"/>
            <a:ext cx="548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D627F65-CDFF-73EC-1348-99A108AF6340}"/>
              </a:ext>
            </a:extLst>
          </p:cNvPr>
          <p:cNvSpPr txBox="1"/>
          <p:nvPr/>
        </p:nvSpPr>
        <p:spPr>
          <a:xfrm>
            <a:off x="638626" y="2968165"/>
            <a:ext cx="548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A064871-B1BD-D0E6-AB5D-6B50C6BBD011}"/>
              </a:ext>
            </a:extLst>
          </p:cNvPr>
          <p:cNvSpPr txBox="1"/>
          <p:nvPr/>
        </p:nvSpPr>
        <p:spPr>
          <a:xfrm>
            <a:off x="638626" y="5312223"/>
            <a:ext cx="548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6A76147-F688-A6A8-C2AF-2ED68F2CC287}"/>
              </a:ext>
            </a:extLst>
          </p:cNvPr>
          <p:cNvSpPr txBox="1"/>
          <p:nvPr/>
        </p:nvSpPr>
        <p:spPr>
          <a:xfrm>
            <a:off x="37837" y="7775051"/>
            <a:ext cx="6740334" cy="1785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</a:t>
            </a:r>
            <a:r>
              <a:rPr lang="en-US" sz="1000" b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3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xpression stability analysis of seven candidate housekeeping genes using control, aphid-fed, and spongy moth-fed samples. (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Each candidate housekeeping gene underwent expression stability analysis using the geNorm tool. A gene expression stability graph was generated based on average stability values (M-value) through a stepwise exclusion process. A lower M-value signifies greater gene stability. Arrows indicate the direction of the most and least stable housekeeping genes. (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NormFinder analysis of the datasets determined the stability values of all examined housekeeping genes, considering both intra and inter-group variation. Genes with lower stability values were deemed the most stable, while those with higher stability values were ranked as the least stable genes. (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Descriptive statistics of candidate genes were obtained using the BestKeeper software. Abbreviations: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M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 geometric mean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M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 athematic mean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in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ax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 threshold values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D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 standard deviation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V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 coefficient of variation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ax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[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xfold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] and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in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[x-fold]: threshold expression levels expressed as absolute x-fold over or under-regulated coefficient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D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[± x-fold] standard deviation of absolute regulation coefficient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84841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7</TotalTime>
  <Words>216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Czech University of Life Sciences Prague 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gilicherla Kanakachari</dc:creator>
  <cp:lastModifiedBy>MDPI</cp:lastModifiedBy>
  <cp:revision>3</cp:revision>
  <dcterms:created xsi:type="dcterms:W3CDTF">2024-05-10T06:35:19Z</dcterms:created>
  <dcterms:modified xsi:type="dcterms:W3CDTF">2024-06-01T09:04:00Z</dcterms:modified>
</cp:coreProperties>
</file>